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17.wmf" ContentType="image/x-wmf"/>
  <Override PartName="/ppt/media/image15.jpeg" ContentType="image/jpeg"/>
  <Override PartName="/ppt/media/image4.jpeg" ContentType="image/jpeg"/>
  <Override PartName="/ppt/media/image16.wmf" ContentType="image/x-wmf"/>
  <Override PartName="/ppt/media/image14.jpeg" ContentType="image/jpeg"/>
  <Override PartName="/ppt/media/image1.jpeg" ContentType="image/jpeg"/>
  <Override PartName="/ppt/media/image2.jpeg" ContentType="image/jpeg"/>
  <Override PartName="/ppt/media/image3.jpeg" ContentType="image/jpeg"/>
  <Override PartName="/ppt/media/image5.jpeg" ContentType="image/jpeg"/>
  <Override PartName="/ppt/media/image8.jpeg" ContentType="image/jpeg"/>
  <Override PartName="/ppt/media/image10.jpeg" ContentType="image/jpeg"/>
  <Override PartName="/ppt/media/image6.jpeg" ContentType="image/jpeg"/>
  <Override PartName="/ppt/media/image7.jpeg" ContentType="image/jpeg"/>
  <Override PartName="/ppt/media/image12.jpeg" ContentType="image/jpe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28.xml" ContentType="application/vnd.openxmlformats-officedocument.presentationml.slide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20.xml.rels" ContentType="application/vnd.openxmlformats-package.relationships+xml"/>
  <Override PartName="/ppt/slides/_rels/slide2.xml.rels" ContentType="application/vnd.openxmlformats-package.relationships+xml"/>
  <Override PartName="/ppt/slides/_rels/slide19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22.xml.rels" ContentType="application/vnd.openxmlformats-package.relationships+xml"/>
  <Override PartName="/ppt/slides/_rels/slide23.xml.rels" ContentType="application/vnd.openxmlformats-package.relationships+xml"/>
  <Override PartName="/ppt/slides/_rels/slide16.xml.rels" ContentType="application/vnd.openxmlformats-package.relationships+xml"/>
  <Override PartName="/ppt/slides/_rels/slide26.xml.rels" ContentType="application/vnd.openxmlformats-package.relationships+xml"/>
  <Override PartName="/ppt/slides/_rels/slide11.xml.rels" ContentType="application/vnd.openxmlformats-package.relationships+xml"/>
  <Override PartName="/ppt/slides/_rels/slide24.xml.rels" ContentType="application/vnd.openxmlformats-package.relationships+xml"/>
  <Override PartName="/ppt/slides/_rels/slide27.xml.rels" ContentType="application/vnd.openxmlformats-package.relationships+xml"/>
  <Override PartName="/ppt/slides/_rels/slide9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28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25.xml.rels" ContentType="application/vnd.openxmlformats-package.relationships+xml"/>
  <Override PartName="/ppt/slides/_rels/slide10.xml.rels" ContentType="application/vnd.openxmlformats-package.relationships+xml"/>
  <Override PartName="/ppt/slides/slide16.xml" ContentType="application/vnd.openxmlformats-officedocument.presentationml.slide+xml"/>
  <Override PartName="/ppt/slides/slide27.xml" ContentType="application/vnd.openxmlformats-officedocument.presentationml.slide+xml"/>
  <Override PartName="/ppt/slides/slide26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30" Type="http://schemas.openxmlformats.org/officeDocument/2006/relationships/slide" Target="slides/slide28.xml"/><Relationship Id="rId3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7F9CDE-B6E0-42FA-9E28-F1535D97784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A4FC91-3EF0-4DEC-804C-1B514B142B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447553-5DC3-43AE-A050-6F8F5340587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2120B9-E608-47A8-B92F-4D6C9591C23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2FA513-7C08-4196-8551-9CEE64A278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34C3BD-C68E-4BDB-BB0C-680D95AA77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787B29-BA51-42DB-B881-1273BC4A2A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AF0062-85A5-4D55-BDE1-89E9EA8C6F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1643CD-50F5-4D77-9429-E4A1A541B8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EF2CE0-B36F-4C17-BCF5-CE1AC54215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BCDF30-C22A-4E63-ACA5-3B1038DBEB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9AF547-BE22-476E-80B2-CA401DA6EE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9141CE0-8DB0-4AB7-B94F-2BA749724B1B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8.jpe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0.jpe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1.jpe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2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14.jpeg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15.jpeg"/><Relationship Id="rId2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16.wmf"/><Relationship Id="rId2" Type="http://schemas.openxmlformats.org/officeDocument/2006/relationships/image" Target="../media/image17.wmf"/><Relationship Id="rId3" Type="http://schemas.openxmlformats.org/officeDocument/2006/relationships/image" Target="../media/image16.wmf"/><Relationship Id="rId4" Type="http://schemas.openxmlformats.org/officeDocument/2006/relationships/image" Target="../media/image16.wmf"/><Relationship Id="rId5" Type="http://schemas.openxmlformats.org/officeDocument/2006/relationships/image" Target="../media/image16.wmf"/><Relationship Id="rId6" Type="http://schemas.openxmlformats.org/officeDocument/2006/relationships/image" Target="../media/image16.wmf"/><Relationship Id="rId7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jmir-shot" descr=""/>
          <p:cNvPicPr/>
          <p:nvPr/>
        </p:nvPicPr>
        <p:blipFill>
          <a:blip r:embed="rId1"/>
          <a:stretch/>
        </p:blipFill>
        <p:spPr>
          <a:xfrm>
            <a:off x="0" y="1959120"/>
            <a:ext cx="9144000" cy="489888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133200" y="0"/>
            <a:ext cx="7828200" cy="1618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000" spc="-1" strike="noStrike">
                <a:solidFill>
                  <a:srgbClr val="000000"/>
                </a:solidFill>
                <a:latin typeface="Times New Roman"/>
              </a:rPr>
              <a:t>Multimedia Appendix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000000"/>
                </a:solidFill>
                <a:latin typeface="Times New Roman"/>
              </a:rPr>
              <a:t>Deftereos S, Lambrinoudakis C, Andriopoulos P, Farmakis D, Aessopos A</a:t>
            </a:r>
            <a:br>
              <a:rPr sz="2000"/>
            </a:br>
            <a:r>
              <a:rPr b="0" lang="de-DE" sz="2000" spc="-1" strike="noStrike">
                <a:solidFill>
                  <a:srgbClr val="000000"/>
                </a:solidFill>
                <a:latin typeface="Times New Roman"/>
              </a:rPr>
              <a:t>A Java-based electronic healthcare record software for beta-thalassaemia</a:t>
            </a:r>
            <a:br>
              <a:rPr sz="2000"/>
            </a:br>
            <a:r>
              <a:rPr b="0" lang="de-DE" sz="2000" spc="-1" strike="noStrike">
                <a:solidFill>
                  <a:srgbClr val="000000"/>
                </a:solidFill>
                <a:latin typeface="Times New Roman"/>
              </a:rPr>
              <a:t>Journal of  Medical Internet Research 2001;3(4):e33</a:t>
            </a:r>
            <a:br>
              <a:rPr sz="2000"/>
            </a:br>
            <a:r>
              <a:rPr b="0" lang="de-DE" sz="2000" spc="-1" strike="noStrike">
                <a:solidFill>
                  <a:srgbClr val="000000"/>
                </a:solidFill>
                <a:latin typeface="Times New Roman"/>
              </a:rPr>
              <a:t>&lt;URL: http://www.jmir.org/2001/4/e33/&gt; 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Data Items...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304920" y="914400"/>
            <a:ext cx="8534160" cy="190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6000"/>
          </a:bodyPr>
          <a:p>
            <a:pPr marL="329040" indent="-32904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Can be groupped in clusters, to achieve the representation of compound concept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29040" indent="-32904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Clusters are </a:t>
            </a:r>
            <a:r>
              <a:rPr b="0" i="1" lang="en-AU" sz="2000" spc="-1" strike="noStrike">
                <a:solidFill>
                  <a:srgbClr val="111173"/>
                </a:solidFill>
                <a:latin typeface="Times New Roman"/>
              </a:rPr>
              <a:t>entitie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29040" indent="-32904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In the figure below, all information on the DFO chelation treatment are groupped in a cluster. None of the individual Data Items can be removed without removing the entire cluster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9" name="Figure3" descr=""/>
          <p:cNvPicPr/>
          <p:nvPr/>
        </p:nvPicPr>
        <p:blipFill>
          <a:blip r:embed="rId1"/>
          <a:stretch/>
        </p:blipFill>
        <p:spPr>
          <a:xfrm>
            <a:off x="762120" y="2971800"/>
            <a:ext cx="7288200" cy="3429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Data Items...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304920" y="914400"/>
            <a:ext cx="8534160" cy="190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6000"/>
          </a:bodyPr>
          <a:p>
            <a:pPr marL="329040" indent="-32904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Can also be groupped in </a:t>
            </a:r>
            <a:r>
              <a:rPr b="0" i="1" lang="en-AU" sz="2000" spc="-1" strike="noStrike">
                <a:solidFill>
                  <a:srgbClr val="111173"/>
                </a:solidFill>
                <a:latin typeface="Times New Roman"/>
              </a:rPr>
              <a:t>Headed Section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29040" indent="-32904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Headed Sections are subdivisions of compositions which are used to group entries with a common theme or derived through a common healthcare proces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29040" indent="-32904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No other constraints are placed on their contents, as opposed to </a:t>
            </a:r>
            <a:r>
              <a:rPr b="0" i="1" lang="en-AU" sz="2000" spc="-1" strike="noStrike">
                <a:solidFill>
                  <a:srgbClr val="111173"/>
                </a:solidFill>
                <a:latin typeface="Times New Roman"/>
              </a:rPr>
              <a:t>Clusters</a:t>
            </a: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. They are not treated as entitie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82" name=""/>
          <p:cNvGrpSpPr/>
          <p:nvPr/>
        </p:nvGrpSpPr>
        <p:grpSpPr>
          <a:xfrm>
            <a:off x="1143000" y="2286000"/>
            <a:ext cx="6705720" cy="4267080"/>
            <a:chOff x="1143000" y="2286000"/>
            <a:chExt cx="6705720" cy="4267080"/>
          </a:xfrm>
        </p:grpSpPr>
        <p:pic>
          <p:nvPicPr>
            <p:cNvPr id="83" name="Figure4" descr=""/>
            <p:cNvPicPr/>
            <p:nvPr/>
          </p:nvPicPr>
          <p:blipFill>
            <a:blip r:embed="rId1"/>
            <a:stretch/>
          </p:blipFill>
          <p:spPr>
            <a:xfrm>
              <a:off x="1219320" y="2743200"/>
              <a:ext cx="6497640" cy="3638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4" name=""/>
            <p:cNvSpPr/>
            <p:nvPr/>
          </p:nvSpPr>
          <p:spPr>
            <a:xfrm>
              <a:off x="1219320" y="3581280"/>
              <a:ext cx="1523880" cy="38124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143000" y="3962520"/>
              <a:ext cx="6705720" cy="259056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 flipV="1">
              <a:off x="2666880" y="2743200"/>
              <a:ext cx="1905120" cy="91440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 flipV="1">
              <a:off x="3476520" y="2760840"/>
              <a:ext cx="1235160" cy="118584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4343400" y="2286000"/>
              <a:ext cx="1905120" cy="4572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A Headed Section: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Heading and Contents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"/>
          <p:cNvSpPr/>
          <p:nvPr/>
        </p:nvSpPr>
        <p:spPr>
          <a:xfrm>
            <a:off x="0" y="0"/>
            <a:ext cx="9144000" cy="13716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Compositions can have diverse  contents...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304920" y="1447920"/>
            <a:ext cx="8534160" cy="152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The contents of compositions are not fixed. They may contain any set of Data Items, in order to record all available informatio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111173"/>
                </a:solidFill>
                <a:latin typeface="Times New Roman"/>
              </a:rPr>
              <a:t>In the example below, an “Endocrinology Check-up” only contains an Oral Glucose Tolerance Test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91" name="Figure5" descr=""/>
          <p:cNvPicPr/>
          <p:nvPr/>
        </p:nvPicPr>
        <p:blipFill>
          <a:blip r:embed="rId1"/>
          <a:stretch/>
        </p:blipFill>
        <p:spPr>
          <a:xfrm>
            <a:off x="914400" y="2895480"/>
            <a:ext cx="6858000" cy="3784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Compositions: another example...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>
            <a:off x="6781680" y="1600200"/>
            <a:ext cx="2057400" cy="281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111173"/>
                </a:solidFill>
                <a:latin typeface="Times New Roman"/>
              </a:rPr>
              <a:t>A “Cardiology evaluation”, which  contains a different set of Data Items than that of the previous example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94" name="Figure6" descr=""/>
          <p:cNvPicPr/>
          <p:nvPr/>
        </p:nvPicPr>
        <p:blipFill>
          <a:blip r:embed="rId1"/>
          <a:stretch/>
        </p:blipFill>
        <p:spPr>
          <a:xfrm>
            <a:off x="228600" y="1066680"/>
            <a:ext cx="6469200" cy="4695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Compositions: a third example...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6781680" y="1600200"/>
            <a:ext cx="2057400" cy="281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111173"/>
                </a:solidFill>
                <a:latin typeface="Times New Roman"/>
              </a:rPr>
              <a:t>A “Liver function check-up”, which  contains another different set of Data Item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97" name="Figure7" descr=""/>
          <p:cNvPicPr/>
          <p:nvPr/>
        </p:nvPicPr>
        <p:blipFill>
          <a:blip r:embed="rId1"/>
          <a:stretch/>
        </p:blipFill>
        <p:spPr>
          <a:xfrm>
            <a:off x="380880" y="1295280"/>
            <a:ext cx="6078600" cy="3133800"/>
          </a:xfrm>
          <a:prstGeom prst="rect">
            <a:avLst/>
          </a:prstGeom>
          <a:ln w="0">
            <a:noFill/>
          </a:ln>
        </p:spPr>
      </p:pic>
      <p:sp>
        <p:nvSpPr>
          <p:cNvPr id="98" name=""/>
          <p:cNvSpPr/>
          <p:nvPr/>
        </p:nvSpPr>
        <p:spPr>
          <a:xfrm>
            <a:off x="380880" y="5105520"/>
            <a:ext cx="8534520" cy="152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The allowed diversity of record contents makes the CEN architecture and JAnaemia suitable for all clinical domain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Data Items have Attributes...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380880" y="990720"/>
            <a:ext cx="8534520" cy="297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…</a:t>
            </a: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which further qualify them. Examples are: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45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AU" sz="1800" spc="-1" strike="noStrike">
                <a:solidFill>
                  <a:srgbClr val="111173"/>
                </a:solidFill>
                <a:latin typeface="Times New Roman"/>
              </a:rPr>
              <a:t>Component Name</a:t>
            </a:r>
            <a:r>
              <a:rPr b="0" lang="en-AU" sz="1800" spc="-1" strike="noStrike">
                <a:solidFill>
                  <a:srgbClr val="111173"/>
                </a:solidFill>
                <a:latin typeface="Times New Roman"/>
              </a:rPr>
              <a:t>: contains the name of a data item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45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AU" sz="1800" spc="-1" strike="noStrike">
                <a:solidFill>
                  <a:srgbClr val="111173"/>
                </a:solidFill>
                <a:latin typeface="Times New Roman"/>
              </a:rPr>
              <a:t>Data Type Item Reference</a:t>
            </a:r>
            <a:r>
              <a:rPr b="0" lang="en-AU" sz="1800" spc="-1" strike="noStrike">
                <a:solidFill>
                  <a:srgbClr val="111173"/>
                </a:solidFill>
                <a:latin typeface="Times New Roman"/>
              </a:rPr>
              <a:t>: the data type of a data item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45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AU" sz="1800" spc="-1" strike="noStrike">
                <a:solidFill>
                  <a:srgbClr val="111173"/>
                </a:solidFill>
                <a:latin typeface="Times New Roman"/>
              </a:rPr>
              <a:t>Data Item Content</a:t>
            </a:r>
            <a:r>
              <a:rPr b="0" lang="en-AU" sz="1800" spc="-1" strike="noStrike">
                <a:solidFill>
                  <a:srgbClr val="111173"/>
                </a:solidFill>
                <a:latin typeface="Times New Roman"/>
              </a:rPr>
              <a:t>: the actual content of a data item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45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AU" sz="1800" spc="-1" strike="noStrike">
                <a:solidFill>
                  <a:srgbClr val="111173"/>
                </a:solidFill>
                <a:latin typeface="Times New Roman"/>
              </a:rPr>
              <a:t>Originating Healthcare Agent</a:t>
            </a:r>
            <a:r>
              <a:rPr b="0" lang="en-AU" sz="1800" spc="-1" strike="noStrike">
                <a:solidFill>
                  <a:srgbClr val="111173"/>
                </a:solidFill>
                <a:latin typeface="Times New Roman"/>
              </a:rPr>
              <a:t>: the healthcare agent that created the data item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45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AU" sz="1800" spc="-1" strike="noStrike">
                <a:solidFill>
                  <a:srgbClr val="111173"/>
                </a:solidFill>
                <a:latin typeface="Times New Roman"/>
              </a:rPr>
              <a:t>Originating Date and Time</a:t>
            </a:r>
            <a:r>
              <a:rPr b="0" lang="en-AU" sz="1800" spc="-1" strike="noStrike">
                <a:solidFill>
                  <a:srgbClr val="111173"/>
                </a:solidFill>
                <a:latin typeface="Times New Roman"/>
              </a:rPr>
              <a:t>: the date and time of creation of the data item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45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AU" sz="1800" spc="-1" strike="noStrike">
                <a:solidFill>
                  <a:srgbClr val="111173"/>
                </a:solidFill>
                <a:latin typeface="Times New Roman"/>
              </a:rPr>
              <a:t>Language</a:t>
            </a:r>
            <a:r>
              <a:rPr b="0" lang="en-AU" sz="1800" spc="-1" strike="noStrike">
                <a:solidFill>
                  <a:srgbClr val="111173"/>
                </a:solidFill>
                <a:latin typeface="Times New Roman"/>
              </a:rPr>
              <a:t>: the language in which the content of the data item is expressed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45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111173"/>
                </a:solidFill>
                <a:latin typeface="Times New Roman"/>
              </a:rPr>
              <a:t>...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45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45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45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51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JAnaemia also allows...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380880" y="990720"/>
            <a:ext cx="8534520" cy="91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Comments on data items to be stored as attribute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The definition of units and normal range, for numeric data item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45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45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45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51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03" name=""/>
          <p:cNvGrpSpPr/>
          <p:nvPr/>
        </p:nvGrpSpPr>
        <p:grpSpPr>
          <a:xfrm>
            <a:off x="609480" y="1905120"/>
            <a:ext cx="7364520" cy="3583080"/>
            <a:chOff x="609480" y="1905120"/>
            <a:chExt cx="7364520" cy="3583080"/>
          </a:xfrm>
        </p:grpSpPr>
        <p:pic>
          <p:nvPicPr>
            <p:cNvPr id="104" name="Figure8" descr=""/>
            <p:cNvPicPr/>
            <p:nvPr/>
          </p:nvPicPr>
          <p:blipFill>
            <a:blip r:embed="rId1"/>
            <a:stretch/>
          </p:blipFill>
          <p:spPr>
            <a:xfrm>
              <a:off x="609480" y="1905120"/>
              <a:ext cx="7364520" cy="2781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5" name=""/>
            <p:cNvSpPr/>
            <p:nvPr/>
          </p:nvSpPr>
          <p:spPr>
            <a:xfrm>
              <a:off x="5321160" y="1940040"/>
              <a:ext cx="2527560" cy="459000"/>
            </a:xfrm>
            <a:prstGeom prst="borderCallout1">
              <a:avLst>
                <a:gd name="adj1" fmla="val 18750"/>
                <a:gd name="adj2" fmla="val -8333"/>
                <a:gd name="adj3" fmla="val 210578"/>
                <a:gd name="adj4" fmla="val -69592"/>
              </a:avLst>
            </a:prstGeom>
            <a:solidFill>
              <a:srgbClr val="ffffff"/>
            </a:solidFill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Units and normal range are defined for HCT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990720" y="3429000"/>
              <a:ext cx="1295280" cy="30492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2514600" y="5029200"/>
              <a:ext cx="2527200" cy="459000"/>
            </a:xfrm>
            <a:prstGeom prst="borderCallout1">
              <a:avLst>
                <a:gd name="adj1" fmla="val 18750"/>
                <a:gd name="adj2" fmla="val -8333"/>
                <a:gd name="adj3" fmla="val -278212"/>
                <a:gd name="adj4" fmla="val -33282"/>
              </a:avLst>
            </a:prstGeom>
            <a:solidFill>
              <a:srgbClr val="ffffff"/>
            </a:solidFill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Values outside the normal range are shown in red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Three additional attributes...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380880" y="1143000"/>
            <a:ext cx="8534520" cy="190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…</a:t>
            </a: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are defined to implement a user-friendly, form-based data entry interface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AU" sz="2000" spc="-1" strike="noStrike">
                <a:solidFill>
                  <a:srgbClr val="111173"/>
                </a:solidFill>
                <a:latin typeface="Times New Roman"/>
              </a:rPr>
              <a:t>XPosition</a:t>
            </a: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 and </a:t>
            </a:r>
            <a:r>
              <a:rPr b="0" i="1" lang="en-AU" sz="2000" spc="-1" strike="noStrike">
                <a:solidFill>
                  <a:srgbClr val="111173"/>
                </a:solidFill>
                <a:latin typeface="Times New Roman"/>
              </a:rPr>
              <a:t>YPosition</a:t>
            </a: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 define the location of data items on the data entry window. Absolute positioning provides design freedom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AU" sz="2000" spc="-1" strike="noStrike">
                <a:solidFill>
                  <a:srgbClr val="111173"/>
                </a:solidFill>
                <a:latin typeface="Times New Roman"/>
              </a:rPr>
              <a:t>Display Type Item Reference</a:t>
            </a: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 defines how a data item should be displayed, depending on its data type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45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45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45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51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10" name=""/>
          <p:cNvGrpSpPr/>
          <p:nvPr/>
        </p:nvGrpSpPr>
        <p:grpSpPr>
          <a:xfrm>
            <a:off x="609480" y="2763720"/>
            <a:ext cx="7974000" cy="3867480"/>
            <a:chOff x="609480" y="2763720"/>
            <a:chExt cx="7974000" cy="3867480"/>
          </a:xfrm>
        </p:grpSpPr>
        <p:pic>
          <p:nvPicPr>
            <p:cNvPr id="111" name="Figure9" descr=""/>
            <p:cNvPicPr/>
            <p:nvPr/>
          </p:nvPicPr>
          <p:blipFill>
            <a:blip r:embed="rId1"/>
            <a:stretch/>
          </p:blipFill>
          <p:spPr>
            <a:xfrm>
              <a:off x="609480" y="3048120"/>
              <a:ext cx="7974000" cy="3524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2" name=""/>
            <p:cNvSpPr/>
            <p:nvPr/>
          </p:nvSpPr>
          <p:spPr>
            <a:xfrm>
              <a:off x="685800" y="3962520"/>
              <a:ext cx="7848720" cy="990360"/>
            </a:xfrm>
            <a:prstGeom prst="rect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4038480" y="2763720"/>
              <a:ext cx="4267440" cy="641520"/>
            </a:xfrm>
            <a:prstGeom prst="borderCallout1">
              <a:avLst>
                <a:gd name="adj1" fmla="val 18750"/>
                <a:gd name="adj2" fmla="val -8333"/>
                <a:gd name="adj3" fmla="val 183398"/>
                <a:gd name="adj4" fmla="val -44787"/>
              </a:avLst>
            </a:prstGeom>
            <a:solidFill>
              <a:srgbClr val="ffffff"/>
            </a:solidFill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Numeric data items may be displayed as Text Fields, Check boxes, Toggle buttons, groups of radio buttons or combo boxes, depending on their expected values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5638680" y="5178600"/>
              <a:ext cx="2514600" cy="641520"/>
            </a:xfrm>
            <a:prstGeom prst="borderCallout1">
              <a:avLst>
                <a:gd name="adj1" fmla="val 18750"/>
                <a:gd name="adj2" fmla="val -8333"/>
                <a:gd name="adj3" fmla="val 10935"/>
                <a:gd name="adj4" fmla="val -28712"/>
              </a:avLst>
            </a:prstGeom>
            <a:solidFill>
              <a:srgbClr val="ffffff"/>
            </a:solidFill>
            <a:ln w="9360">
              <a:solidFill>
                <a:srgbClr val="11117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Text data items are displayed as specialized edit windows or combo boxes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5715000" y="6095880"/>
              <a:ext cx="2514600" cy="459000"/>
            </a:xfrm>
            <a:prstGeom prst="borderCallout1">
              <a:avLst>
                <a:gd name="adj1" fmla="val 18750"/>
                <a:gd name="adj2" fmla="val -8333"/>
                <a:gd name="adj3" fmla="val -99291"/>
                <a:gd name="adj4" fmla="val -72472"/>
              </a:avLst>
            </a:prstGeom>
            <a:solidFill>
              <a:srgbClr val="ffffff"/>
            </a:solidFill>
            <a:ln w="93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Date/time data items are displayed as Text fields or combo boxes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609480" y="6172200"/>
              <a:ext cx="2514600" cy="459000"/>
            </a:xfrm>
            <a:prstGeom prst="borderCallout1">
              <a:avLst>
                <a:gd name="adj1" fmla="val 18750"/>
                <a:gd name="adj2" fmla="val -8333"/>
                <a:gd name="adj3" fmla="val -39259"/>
                <a:gd name="adj4" fmla="val 138115"/>
              </a:avLst>
            </a:prstGeom>
            <a:solidFill>
              <a:srgbClr val="ffffff"/>
            </a:solidFill>
            <a:ln w="936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Multimedia objects have their own display type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A fourth additional attribute...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380880" y="1143000"/>
            <a:ext cx="8534520" cy="144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…</a:t>
            </a: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is used to define the automatic data processing behavior of data item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00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AU" sz="2000" spc="-1" strike="noStrike">
                <a:solidFill>
                  <a:srgbClr val="111173"/>
                </a:solidFill>
                <a:latin typeface="Times New Roman"/>
              </a:rPr>
              <a:t>Macro-directive </a:t>
            </a: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associates a macro directive with a data item </a:t>
            </a:r>
            <a:r>
              <a:rPr b="0" lang="en-AU" sz="1600" spc="-1" strike="noStrike">
                <a:solidFill>
                  <a:srgbClr val="111173"/>
                </a:solidFill>
                <a:latin typeface="Times New Roman"/>
              </a:rPr>
              <a:t>(Macro-directives are defined, in the context of our work, as statements capable of retrieving and processing the contents of data items, and of assigning values to them)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19" name=""/>
          <p:cNvGrpSpPr/>
          <p:nvPr/>
        </p:nvGrpSpPr>
        <p:grpSpPr>
          <a:xfrm>
            <a:off x="152280" y="2438280"/>
            <a:ext cx="8796600" cy="2590920"/>
            <a:chOff x="152280" y="2438280"/>
            <a:chExt cx="8796600" cy="2590920"/>
          </a:xfrm>
        </p:grpSpPr>
        <p:pic>
          <p:nvPicPr>
            <p:cNvPr id="120" name="Figure10" descr=""/>
            <p:cNvPicPr/>
            <p:nvPr/>
          </p:nvPicPr>
          <p:blipFill>
            <a:blip r:embed="rId1"/>
            <a:stretch/>
          </p:blipFill>
          <p:spPr>
            <a:xfrm>
              <a:off x="152280" y="2438280"/>
              <a:ext cx="8796600" cy="2286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1" name=""/>
            <p:cNvSpPr/>
            <p:nvPr/>
          </p:nvSpPr>
          <p:spPr>
            <a:xfrm flipV="1">
              <a:off x="2286000" y="2701800"/>
              <a:ext cx="1720800" cy="65088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2" name=""/>
            <p:cNvSpPr/>
            <p:nvPr/>
          </p:nvSpPr>
          <p:spPr>
            <a:xfrm flipV="1">
              <a:off x="2743200" y="2765520"/>
              <a:ext cx="1314360" cy="142560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3" name=""/>
            <p:cNvSpPr/>
            <p:nvPr/>
          </p:nvSpPr>
          <p:spPr>
            <a:xfrm flipV="1">
              <a:off x="3048120" y="3072960"/>
              <a:ext cx="1245960" cy="149868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4038480" y="2438280"/>
              <a:ext cx="236232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Parameters fed into the system by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the user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3809880" y="3962520"/>
              <a:ext cx="5105520" cy="106668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11117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1600200" y="4724280"/>
              <a:ext cx="1066680" cy="304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11117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Derived results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1905120" y="3809880"/>
              <a:ext cx="152280" cy="838440"/>
            </a:xfrm>
            <a:prstGeom prst="line">
              <a:avLst/>
            </a:prstGeom>
            <a:ln w="9360">
              <a:solidFill>
                <a:srgbClr val="11117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8" name=""/>
            <p:cNvSpPr/>
            <p:nvPr/>
          </p:nvSpPr>
          <p:spPr>
            <a:xfrm flipH="1">
              <a:off x="2666520" y="4724280"/>
              <a:ext cx="1143000" cy="228600"/>
            </a:xfrm>
            <a:prstGeom prst="line">
              <a:avLst/>
            </a:prstGeom>
            <a:ln w="9360">
              <a:solidFill>
                <a:srgbClr val="11117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29" name=""/>
          <p:cNvSpPr/>
          <p:nvPr/>
        </p:nvSpPr>
        <p:spPr>
          <a:xfrm>
            <a:off x="304920" y="5105520"/>
            <a:ext cx="8534160" cy="144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The above figure provides an example of automatic data processing behaviour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The complexity of the allowed processing in unlimited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Macro-directives can thus significantly aid users in their clinical work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Facilitating medical research...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>
            <a:off x="380880" y="762120"/>
            <a:ext cx="8534520" cy="236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8000"/>
          </a:bodyPr>
          <a:p>
            <a:pPr marL="335880" indent="-3358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Patient records searches can be performed, using any combination of user-defined criteria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35880" indent="-3358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For all matching records, the values of user-defined data items can be displayed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35880" indent="-3358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Elementary statistics are built-i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35880" indent="-3358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Specialized processing allows search results to be directly exportable to statistical packages, such as SPSS or SA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32" name=""/>
          <p:cNvGrpSpPr/>
          <p:nvPr/>
        </p:nvGrpSpPr>
        <p:grpSpPr>
          <a:xfrm>
            <a:off x="533520" y="3065400"/>
            <a:ext cx="8205840" cy="3716280"/>
            <a:chOff x="533520" y="3065400"/>
            <a:chExt cx="8205840" cy="3716280"/>
          </a:xfrm>
        </p:grpSpPr>
        <p:pic>
          <p:nvPicPr>
            <p:cNvPr id="133" name="Figure11" descr=""/>
            <p:cNvPicPr/>
            <p:nvPr/>
          </p:nvPicPr>
          <p:blipFill>
            <a:blip r:embed="rId1"/>
            <a:stretch/>
          </p:blipFill>
          <p:spPr>
            <a:xfrm>
              <a:off x="533520" y="3206880"/>
              <a:ext cx="8205840" cy="3574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4" name=""/>
            <p:cNvSpPr/>
            <p:nvPr/>
          </p:nvSpPr>
          <p:spPr>
            <a:xfrm>
              <a:off x="6310440" y="3065400"/>
              <a:ext cx="1004760" cy="459000"/>
            </a:xfrm>
            <a:prstGeom prst="borderCallout1">
              <a:avLst>
                <a:gd name="adj1" fmla="val 18750"/>
                <a:gd name="adj2" fmla="val -8333"/>
                <a:gd name="adj3" fmla="val 115907"/>
                <a:gd name="adj4" fmla="val -138069"/>
              </a:avLst>
            </a:prstGeom>
            <a:solidFill>
              <a:srgbClr val="ffffff"/>
            </a:solidFill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Search criteria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5" name=""/>
            <p:cNvSpPr/>
            <p:nvPr/>
          </p:nvSpPr>
          <p:spPr>
            <a:xfrm rot="5400000">
              <a:off x="3657240" y="1981080"/>
              <a:ext cx="304560" cy="5638680"/>
            </a:xfrm>
            <a:custGeom>
              <a:avLst/>
              <a:gdLst>
                <a:gd name="textAreaLeft" fmla="*/ 89640 w 304560"/>
                <a:gd name="textAreaRight" fmla="*/ 304920 w 304560"/>
                <a:gd name="textAreaTop" fmla="*/ 234720 h 5638680"/>
                <a:gd name="textAreaBottom" fmla="*/ 5403960 h 563868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0800" y="0"/>
                    <a:pt x="0" y="900"/>
                    <a:pt x="0" y="1800"/>
                  </a:cubicBezTo>
                  <a:lnTo>
                    <a:pt x="0" y="19800"/>
                  </a:lnTo>
                  <a:cubicBezTo>
                    <a:pt x="0" y="20700"/>
                    <a:pt x="108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11117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4495680" y="4191120"/>
              <a:ext cx="3154320" cy="276480"/>
            </a:xfrm>
            <a:prstGeom prst="borderCallout1">
              <a:avLst>
                <a:gd name="adj1" fmla="val 18750"/>
                <a:gd name="adj2" fmla="val -8333"/>
                <a:gd name="adj3" fmla="val 156435"/>
                <a:gd name="adj4" fmla="val -44078"/>
              </a:avLst>
            </a:prstGeom>
            <a:solidFill>
              <a:srgbClr val="ffffff"/>
            </a:solidFill>
            <a:ln w="9360">
              <a:solidFill>
                <a:srgbClr val="11117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Matching records (patient names are hidden)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4038480" y="5786280"/>
              <a:ext cx="2416320" cy="459000"/>
            </a:xfrm>
            <a:prstGeom prst="borderCallout1">
              <a:avLst>
                <a:gd name="adj1" fmla="val 18750"/>
                <a:gd name="adj2" fmla="val -8333"/>
                <a:gd name="adj3" fmla="val 37615"/>
                <a:gd name="adj4" fmla="val 162069"/>
              </a:avLst>
            </a:prstGeom>
            <a:solidFill>
              <a:srgbClr val="ffffff"/>
            </a:solidFill>
            <a:ln w="93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TSH values are reported for all matching records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0" y="762120"/>
            <a:ext cx="9144000" cy="2133360"/>
          </a:xfrm>
          <a:prstGeom prst="rect">
            <a:avLst/>
          </a:prstGeom>
          <a:noFill/>
          <a:ln w="0">
            <a:noFill/>
          </a:ln>
          <a:effectLst>
            <a:outerShdw dist="45929" dir="3371122" blurRad="0" rotWithShape="0">
              <a:srgbClr val="808080"/>
            </a:outerShdw>
          </a:effectLst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111173"/>
                </a:solidFill>
                <a:latin typeface="Times New Roman"/>
              </a:rPr>
              <a:t>A Java-based Electronic Healthcare Record software for</a:t>
            </a:r>
            <a:br>
              <a:rPr sz="4400"/>
            </a:br>
            <a:r>
              <a:rPr b="1" lang="en-US" sz="4400" spc="-1" strike="noStrike">
                <a:solidFill>
                  <a:srgbClr val="111173"/>
                </a:solidFill>
                <a:latin typeface="Times New Roman"/>
              </a:rPr>
              <a:t>beta-Thalassaemia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 type="subTitle"/>
          </p:nvPr>
        </p:nvSpPr>
        <p:spPr>
          <a:xfrm>
            <a:off x="0" y="3276360"/>
            <a:ext cx="9144000" cy="297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 u="sng">
                <a:solidFill>
                  <a:srgbClr val="540010"/>
                </a:solidFill>
                <a:uFillTx/>
                <a:latin typeface="Times New Roman"/>
              </a:rPr>
              <a:t>Deftereos S., MD, PhD</a:t>
            </a:r>
            <a:r>
              <a:rPr b="1" lang="en-US" sz="2400" spc="-1" strike="noStrike" baseline="30000">
                <a:solidFill>
                  <a:srgbClr val="540010"/>
                </a:solidFill>
                <a:latin typeface="Times New Roman"/>
              </a:rPr>
              <a:t>1</a:t>
            </a:r>
            <a:r>
              <a:rPr b="1" lang="en-US" sz="2400" spc="-1" strike="noStrike">
                <a:solidFill>
                  <a:srgbClr val="540010"/>
                </a:solidFill>
                <a:latin typeface="Times New Roman"/>
              </a:rPr>
              <a:t>,  </a:t>
            </a:r>
            <a:r>
              <a:rPr b="0" lang="en-US" sz="2400" spc="-1" strike="noStrike">
                <a:solidFill>
                  <a:srgbClr val="540010"/>
                </a:solidFill>
                <a:latin typeface="Times New Roman"/>
              </a:rPr>
              <a:t>Lambrinoudakis C., Lecturer</a:t>
            </a:r>
            <a:r>
              <a:rPr b="0" lang="en-US" sz="2400" spc="-1" strike="noStrike" baseline="30000">
                <a:solidFill>
                  <a:srgbClr val="540010"/>
                </a:solidFill>
                <a:latin typeface="Times New Roman"/>
              </a:rPr>
              <a:t>2</a:t>
            </a:r>
            <a:r>
              <a:rPr b="0" lang="en-US" sz="2400" spc="-1" strike="noStrike">
                <a:solidFill>
                  <a:srgbClr val="540010"/>
                </a:solidFill>
                <a:latin typeface="Times New Roman"/>
              </a:rPr>
              <a:t>, Andriopoulos P., MD</a:t>
            </a:r>
            <a:r>
              <a:rPr b="0" lang="en-US" sz="2400" spc="-1" strike="noStrike" baseline="30000">
                <a:solidFill>
                  <a:srgbClr val="540010"/>
                </a:solidFill>
                <a:latin typeface="Times New Roman"/>
              </a:rPr>
              <a:t>3</a:t>
            </a:r>
            <a:r>
              <a:rPr b="0" lang="en-US" sz="2400" spc="-1" strike="noStrike">
                <a:solidFill>
                  <a:srgbClr val="540010"/>
                </a:solidFill>
                <a:latin typeface="Times New Roman"/>
              </a:rPr>
              <a:t>, Farmakis D., MD</a:t>
            </a:r>
            <a:r>
              <a:rPr b="0" lang="en-US" sz="2400" spc="-1" strike="noStrike" baseline="30000">
                <a:solidFill>
                  <a:srgbClr val="540010"/>
                </a:solidFill>
                <a:latin typeface="Times New Roman"/>
              </a:rPr>
              <a:t>1</a:t>
            </a:r>
            <a:r>
              <a:rPr b="0" lang="en-US" sz="2400" spc="-1" strike="noStrike">
                <a:solidFill>
                  <a:srgbClr val="540010"/>
                </a:solidFill>
                <a:latin typeface="Times New Roman"/>
              </a:rPr>
              <a:t>, Aessopos A., Assoc. Prof.</a:t>
            </a:r>
            <a:r>
              <a:rPr b="0" lang="en-US" sz="2400" spc="-1" strike="noStrike" baseline="30000">
                <a:solidFill>
                  <a:srgbClr val="540010"/>
                </a:solidFill>
                <a:latin typeface="Times New Roman"/>
              </a:rPr>
              <a:t>1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indent="0" algn="ctr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indent="0" algn="ctr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 baseline="30000">
                <a:solidFill>
                  <a:srgbClr val="111173"/>
                </a:solidFill>
                <a:latin typeface="Times New Roman"/>
              </a:rPr>
              <a:t>1 </a:t>
            </a:r>
            <a:r>
              <a:rPr b="0" lang="en-US" sz="1600" spc="-1" strike="noStrike">
                <a:solidFill>
                  <a:srgbClr val="111173"/>
                </a:solidFill>
                <a:latin typeface="Times New Roman"/>
              </a:rPr>
              <a:t>First Dept. of Internal Medicine, University of Athens, Medical School, “Laiko” Hospital, Ag. Thoma 17, 11527, Athens, Greece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indent="0" algn="ctr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 baseline="30000">
                <a:solidFill>
                  <a:srgbClr val="111173"/>
                </a:solidFill>
                <a:latin typeface="Times New Roman"/>
              </a:rPr>
              <a:t>2 </a:t>
            </a:r>
            <a:r>
              <a:rPr b="0" lang="en-US" sz="1600" spc="-1" strike="noStrike">
                <a:solidFill>
                  <a:srgbClr val="111173"/>
                </a:solidFill>
                <a:latin typeface="Times New Roman"/>
              </a:rPr>
              <a:t>Department of Information and Communication Systems, University of the Aegean, Karlovasi, 83200 Samos, Greece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indent="0" algn="ctr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 baseline="30000">
                <a:solidFill>
                  <a:srgbClr val="111173"/>
                </a:solidFill>
                <a:latin typeface="Times New Roman"/>
              </a:rPr>
              <a:t>3</a:t>
            </a:r>
            <a:r>
              <a:rPr b="0" lang="en-US" sz="1600" spc="-1" strike="noStrike">
                <a:solidFill>
                  <a:srgbClr val="111173"/>
                </a:solidFill>
                <a:latin typeface="Times New Roman"/>
              </a:rPr>
              <a:t> General Hospital of Sparti, Sparti, Greece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Alternative data presentations...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>
            <a:off x="380880" y="990720"/>
            <a:ext cx="8610840" cy="190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Any number of user-defined parameters can be presented in a tabular format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This allows healthcare professionals to monitor the evolution of a patient’s health status and to easily compare parameter value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In the example below, progressive values of the patient weight are presented, together with their corresponding dates of recording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40" name="Figure13" descr=""/>
          <p:cNvPicPr/>
          <p:nvPr/>
        </p:nvPicPr>
        <p:blipFill>
          <a:blip r:embed="rId1"/>
          <a:stretch/>
        </p:blipFill>
        <p:spPr>
          <a:xfrm>
            <a:off x="533520" y="3124080"/>
            <a:ext cx="8229600" cy="2090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Graphical representation...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"/>
          <p:cNvSpPr/>
          <p:nvPr/>
        </p:nvSpPr>
        <p:spPr>
          <a:xfrm>
            <a:off x="380880" y="990720"/>
            <a:ext cx="8610840" cy="99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111173"/>
                </a:solidFill>
                <a:latin typeface="Times New Roman"/>
              </a:rPr>
              <a:t>JAnaemia can represent graphically the successive values of user-defined sets of parameter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43" name="Figure14" descr=""/>
          <p:cNvPicPr/>
          <p:nvPr/>
        </p:nvPicPr>
        <p:blipFill>
          <a:blip r:embed="rId1"/>
          <a:stretch/>
        </p:blipFill>
        <p:spPr>
          <a:xfrm>
            <a:off x="360360" y="2290680"/>
            <a:ext cx="8421840" cy="2276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Reducing paper work ...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"/>
          <p:cNvSpPr/>
          <p:nvPr/>
        </p:nvSpPr>
        <p:spPr>
          <a:xfrm>
            <a:off x="380880" y="1143000"/>
            <a:ext cx="8534520" cy="990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1000"/>
          </a:bodyPr>
          <a:p>
            <a:pPr marL="312120" indent="-31212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AU" sz="2000" spc="-1" strike="noStrike">
                <a:solidFill>
                  <a:srgbClr val="111173"/>
                </a:solidFill>
                <a:latin typeface="Times New Roman"/>
              </a:rPr>
              <a:t>Document templates</a:t>
            </a: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 can be automatically filled in with patient data and can be directly printed and used apporpriatly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12120" indent="-31212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111173"/>
                </a:solidFill>
                <a:latin typeface="Times New Roman"/>
              </a:rPr>
              <a:t>The figure below shows a cardiology report (in Greek)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46" name="Figure12" descr=""/>
          <p:cNvPicPr/>
          <p:nvPr/>
        </p:nvPicPr>
        <p:blipFill>
          <a:blip r:embed="rId1"/>
          <a:stretch/>
        </p:blipFill>
        <p:spPr>
          <a:xfrm>
            <a:off x="1333440" y="2233440"/>
            <a:ext cx="6019920" cy="4515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Records can be shared ...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"/>
          <p:cNvSpPr/>
          <p:nvPr/>
        </p:nvSpPr>
        <p:spPr>
          <a:xfrm>
            <a:off x="380880" y="1143000"/>
            <a:ext cx="853452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Either through access to the same EHCR repository...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49" name=""/>
          <p:cNvGrpSpPr/>
          <p:nvPr/>
        </p:nvGrpSpPr>
        <p:grpSpPr>
          <a:xfrm>
            <a:off x="380880" y="1676520"/>
            <a:ext cx="8077320" cy="2666880"/>
            <a:chOff x="380880" y="1676520"/>
            <a:chExt cx="8077320" cy="2666880"/>
          </a:xfrm>
        </p:grpSpPr>
        <p:pic>
          <p:nvPicPr>
            <p:cNvPr id="150" name="COMPUTR2" descr=""/>
            <p:cNvPicPr/>
            <p:nvPr/>
          </p:nvPicPr>
          <p:blipFill>
            <a:blip r:embed="rId1"/>
            <a:stretch/>
          </p:blipFill>
          <p:spPr>
            <a:xfrm>
              <a:off x="380880" y="1676520"/>
              <a:ext cx="1352520" cy="933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1" name="SERVER" descr=""/>
            <p:cNvPicPr/>
            <p:nvPr/>
          </p:nvPicPr>
          <p:blipFill>
            <a:blip r:embed="rId2"/>
            <a:stretch/>
          </p:blipFill>
          <p:spPr>
            <a:xfrm>
              <a:off x="2666880" y="2438280"/>
              <a:ext cx="798480" cy="1144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2" name="COMPUTR2" descr=""/>
            <p:cNvPicPr/>
            <p:nvPr/>
          </p:nvPicPr>
          <p:blipFill>
            <a:blip r:embed="rId3"/>
            <a:stretch/>
          </p:blipFill>
          <p:spPr>
            <a:xfrm>
              <a:off x="5181480" y="1752480"/>
              <a:ext cx="1352520" cy="933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3" name="COMPUTR2" descr=""/>
            <p:cNvPicPr/>
            <p:nvPr/>
          </p:nvPicPr>
          <p:blipFill>
            <a:blip r:embed="rId4"/>
            <a:stretch/>
          </p:blipFill>
          <p:spPr>
            <a:xfrm>
              <a:off x="7086600" y="2971800"/>
              <a:ext cx="1352520" cy="933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4" name=""/>
            <p:cNvSpPr/>
            <p:nvPr/>
          </p:nvSpPr>
          <p:spPr>
            <a:xfrm>
              <a:off x="380880" y="2666880"/>
              <a:ext cx="1295640" cy="3812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111173"/>
                  </a:solidFill>
                  <a:latin typeface="Times New Roman"/>
                </a:rPr>
                <a:t>JAnaemia client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5105520" y="2743200"/>
              <a:ext cx="1295280" cy="3808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111173"/>
                  </a:solidFill>
                  <a:latin typeface="Times New Roman"/>
                </a:rPr>
                <a:t>JAnaemia client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7162920" y="3962520"/>
              <a:ext cx="1295280" cy="3808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111173"/>
                  </a:solidFill>
                  <a:latin typeface="Times New Roman"/>
                </a:rPr>
                <a:t>JAnaemia client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2133720" y="3657600"/>
              <a:ext cx="1904760" cy="3808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111173"/>
                  </a:solidFill>
                  <a:latin typeface="Times New Roman"/>
                </a:rPr>
                <a:t>EHCR Repository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111173"/>
                  </a:solidFill>
                  <a:latin typeface="Times New Roman"/>
                </a:rPr>
                <a:t>(Database Server)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cxnSp>
          <p:nvCxnSpPr>
            <p:cNvPr id="158" name=""/>
            <p:cNvCxnSpPr>
              <a:stCxn id="150" idx="3"/>
              <a:endCxn id="151" idx="2"/>
            </p:cNvCxnSpPr>
            <p:nvPr/>
          </p:nvCxnSpPr>
          <p:spPr>
            <a:xfrm>
              <a:off x="1733040" y="2143080"/>
              <a:ext cx="1334520" cy="1440360"/>
            </a:xfrm>
            <a:prstGeom prst="straightConnector1">
              <a:avLst/>
            </a:prstGeom>
            <a:ln w="9360">
              <a:solidFill>
                <a:srgbClr val="111173"/>
              </a:solidFill>
              <a:miter/>
              <a:tailEnd len="med" type="triangle" w="med"/>
            </a:ln>
          </p:spPr>
        </p:cxnSp>
        <p:cxnSp>
          <p:nvCxnSpPr>
            <p:cNvPr id="159" name=""/>
            <p:cNvCxnSpPr>
              <a:stCxn id="152" idx="1"/>
              <a:endCxn id="151" idx="3"/>
            </p:cNvCxnSpPr>
            <p:nvPr/>
          </p:nvCxnSpPr>
          <p:spPr>
            <a:xfrm flipH="1">
              <a:off x="3464640" y="2219400"/>
              <a:ext cx="1716840" cy="792720"/>
            </a:xfrm>
            <a:prstGeom prst="straightConnector1">
              <a:avLst/>
            </a:prstGeom>
            <a:ln w="9360">
              <a:solidFill>
                <a:srgbClr val="111173"/>
              </a:solidFill>
              <a:miter/>
              <a:tailEnd len="med" type="triangle" w="med"/>
            </a:ln>
          </p:spPr>
        </p:cxnSp>
        <p:cxnSp>
          <p:nvCxnSpPr>
            <p:cNvPr id="160" name=""/>
            <p:cNvCxnSpPr>
              <a:stCxn id="153" idx="2"/>
              <a:endCxn id="151" idx="3"/>
            </p:cNvCxnSpPr>
            <p:nvPr/>
          </p:nvCxnSpPr>
          <p:spPr>
            <a:xfrm flipH="1" flipV="1">
              <a:off x="3465360" y="3010680"/>
              <a:ext cx="4298040" cy="894600"/>
            </a:xfrm>
            <a:prstGeom prst="straightConnector1">
              <a:avLst/>
            </a:prstGeom>
            <a:ln w="9360">
              <a:solidFill>
                <a:srgbClr val="111173"/>
              </a:solidFill>
              <a:miter/>
              <a:tailEnd len="med" type="triangle" w="med"/>
            </a:ln>
          </p:spPr>
        </p:cxnSp>
      </p:grpSp>
      <p:sp>
        <p:nvSpPr>
          <p:cNvPr id="161" name=""/>
          <p:cNvSpPr/>
          <p:nvPr/>
        </p:nvSpPr>
        <p:spPr>
          <a:xfrm>
            <a:off x="228600" y="4495680"/>
            <a:ext cx="853452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Or via exchange messages (based on XML, currently under development)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62" name=""/>
          <p:cNvGrpSpPr/>
          <p:nvPr/>
        </p:nvGrpSpPr>
        <p:grpSpPr>
          <a:xfrm>
            <a:off x="533520" y="5029200"/>
            <a:ext cx="6153120" cy="1447920"/>
            <a:chOff x="533520" y="5029200"/>
            <a:chExt cx="6153120" cy="1447920"/>
          </a:xfrm>
        </p:grpSpPr>
        <p:pic>
          <p:nvPicPr>
            <p:cNvPr id="163" name="COMPUTR2" descr=""/>
            <p:cNvPicPr/>
            <p:nvPr/>
          </p:nvPicPr>
          <p:blipFill>
            <a:blip r:embed="rId5"/>
            <a:stretch/>
          </p:blipFill>
          <p:spPr>
            <a:xfrm>
              <a:off x="533520" y="5029200"/>
              <a:ext cx="1352520" cy="933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4" name="COMPUTR2" descr=""/>
            <p:cNvPicPr/>
            <p:nvPr/>
          </p:nvPicPr>
          <p:blipFill>
            <a:blip r:embed="rId6"/>
            <a:stretch/>
          </p:blipFill>
          <p:spPr>
            <a:xfrm>
              <a:off x="5334120" y="5105520"/>
              <a:ext cx="1352520" cy="933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5" name=""/>
            <p:cNvSpPr/>
            <p:nvPr/>
          </p:nvSpPr>
          <p:spPr>
            <a:xfrm>
              <a:off x="533520" y="6019920"/>
              <a:ext cx="1295280" cy="3808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111173"/>
                  </a:solidFill>
                  <a:latin typeface="Times New Roman"/>
                </a:rPr>
                <a:t>JAnaemia client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5257800" y="6095880"/>
              <a:ext cx="1295280" cy="3812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111173"/>
                  </a:solidFill>
                  <a:latin typeface="Times New Roman"/>
                </a:rPr>
                <a:t>JAnaemia client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cxnSp>
          <p:nvCxnSpPr>
            <p:cNvPr id="167" name=""/>
            <p:cNvCxnSpPr>
              <a:stCxn id="163" idx="2"/>
              <a:endCxn id="164" idx="2"/>
            </p:cNvCxnSpPr>
            <p:nvPr/>
          </p:nvCxnSpPr>
          <p:spPr>
            <a:xfrm>
              <a:off x="1209240" y="5962680"/>
              <a:ext cx="4801320" cy="76680"/>
            </a:xfrm>
            <a:prstGeom prst="straightConnector1">
              <a:avLst/>
            </a:prstGeom>
            <a:ln w="9360">
              <a:solidFill>
                <a:srgbClr val="111173"/>
              </a:solidFill>
              <a:miter/>
              <a:headEnd len="med" type="triangle" w="med"/>
              <a:tailEnd len="med" type="triangle" w="med"/>
            </a:ln>
          </p:spPr>
        </p:cxnSp>
        <p:sp>
          <p:nvSpPr>
            <p:cNvPr id="168" name=""/>
            <p:cNvSpPr/>
            <p:nvPr/>
          </p:nvSpPr>
          <p:spPr>
            <a:xfrm>
              <a:off x="2743200" y="5486400"/>
              <a:ext cx="2057400" cy="3808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111173"/>
                  </a:solidFill>
                  <a:latin typeface="Times New Roman"/>
                </a:rPr>
                <a:t>EHCR Exchange messages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Record sharing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"/>
          <p:cNvSpPr/>
          <p:nvPr/>
        </p:nvSpPr>
        <p:spPr>
          <a:xfrm>
            <a:off x="380880" y="1143000"/>
            <a:ext cx="8534520" cy="1219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In both sharing scenarios patient records are accompanied by appropriate </a:t>
            </a:r>
            <a:r>
              <a:rPr b="0" i="1" lang="en-AU" sz="2000" spc="-1" strike="noStrike">
                <a:solidFill>
                  <a:srgbClr val="111173"/>
                </a:solidFill>
                <a:latin typeface="Times New Roman"/>
              </a:rPr>
              <a:t>distribution rules</a:t>
            </a: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, which control their access and distributio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Additional Functionality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"/>
          <p:cNvSpPr/>
          <p:nvPr/>
        </p:nvSpPr>
        <p:spPr>
          <a:xfrm>
            <a:off x="380880" y="1143000"/>
            <a:ext cx="8534520" cy="335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8000"/>
          </a:bodyPr>
          <a:p>
            <a:pPr marL="335880" indent="-3358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AU" sz="2000" spc="-1" strike="noStrike">
                <a:solidFill>
                  <a:srgbClr val="111173"/>
                </a:solidFill>
                <a:latin typeface="Times New Roman"/>
              </a:rPr>
              <a:t>Customizability to individual user needs</a:t>
            </a: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: data items can be combined in predefined sets (</a:t>
            </a:r>
            <a:r>
              <a:rPr b="0" i="1" lang="en-AU" sz="2000" spc="-1" strike="noStrike">
                <a:solidFill>
                  <a:srgbClr val="111173"/>
                </a:solidFill>
                <a:latin typeface="Times New Roman"/>
              </a:rPr>
              <a:t>data item sets</a:t>
            </a: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). Their contents are user-defined and can be used as data-entry form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35880" indent="-3358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AU" sz="2000" spc="-1" strike="noStrike">
                <a:solidFill>
                  <a:srgbClr val="111173"/>
                </a:solidFill>
                <a:latin typeface="Times New Roman"/>
              </a:rPr>
              <a:t>Multilinguality</a:t>
            </a: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: coded contents are automatically translated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35880" indent="-3358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AU" sz="2000" spc="-1" strike="noStrike">
                <a:solidFill>
                  <a:srgbClr val="111173"/>
                </a:solidFill>
                <a:latin typeface="Times New Roman"/>
              </a:rPr>
              <a:t>Educational access</a:t>
            </a: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: students can access all record contents, with the exception of administrative informatio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35880" indent="-3358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AU" sz="2000" spc="-1" strike="noStrike">
                <a:solidFill>
                  <a:srgbClr val="111173"/>
                </a:solidFill>
                <a:latin typeface="Times New Roman"/>
              </a:rPr>
              <a:t>Audit trail</a:t>
            </a: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: all amendements of compositions are recorded in their successive </a:t>
            </a:r>
            <a:r>
              <a:rPr b="0" i="1" lang="en-AU" sz="2000" spc="-1" strike="noStrike">
                <a:solidFill>
                  <a:srgbClr val="111173"/>
                </a:solidFill>
                <a:latin typeface="Times New Roman"/>
              </a:rPr>
              <a:t>version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35880" indent="-3358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000" spc="-1" strike="noStrike">
                <a:solidFill>
                  <a:srgbClr val="111173"/>
                </a:solidFill>
                <a:latin typeface="Times New Roman"/>
              </a:rPr>
              <a:t>Compliance check</a:t>
            </a:r>
            <a:r>
              <a:rPr b="0" lang="en-US" sz="2000" spc="-1" strike="noStrike">
                <a:solidFill>
                  <a:srgbClr val="111173"/>
                </a:solidFill>
                <a:latin typeface="Times New Roman"/>
              </a:rPr>
              <a:t>: the system can locate patients that do not adhere to their follow-up schedule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"/>
          <p:cNvSpPr/>
          <p:nvPr/>
        </p:nvSpPr>
        <p:spPr>
          <a:xfrm>
            <a:off x="0" y="457200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Functionality under development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"/>
          <p:cNvSpPr/>
          <p:nvPr/>
        </p:nvSpPr>
        <p:spPr>
          <a:xfrm>
            <a:off x="380880" y="5638680"/>
            <a:ext cx="8534520" cy="83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Patient record exchange message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Smart-card based record exchange mechanism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5" name="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Status Report 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"/>
          <p:cNvSpPr/>
          <p:nvPr/>
        </p:nvSpPr>
        <p:spPr>
          <a:xfrm>
            <a:off x="380880" y="1143000"/>
            <a:ext cx="8610840" cy="380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JAnaemia is currently operational at: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45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111173"/>
                </a:solidFill>
                <a:latin typeface="Times New Roman"/>
              </a:rPr>
              <a:t>The Thalasseamia Unit of the “Ag. Sophia” Childrens’ hospital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45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111173"/>
                </a:solidFill>
                <a:latin typeface="Times New Roman"/>
              </a:rPr>
              <a:t>The First  Internal Medicine Department of the “Laiko” hospital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45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111173"/>
                </a:solidFill>
                <a:latin typeface="Times New Roman"/>
              </a:rPr>
              <a:t>The Thalasseamia Unit of the hospital of Korinthos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45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111173"/>
                </a:solidFill>
                <a:latin typeface="Times New Roman"/>
              </a:rPr>
              <a:t>The Pediatric Department of the hospital of Sparti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Ten data item sets have been produced, which cover all information storage and processing needs of beta-Thalassemia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The contents of the ten basic data item sets vary among the participating hospitals. Additional sets have been produced for “Ag. Sophia” due to their specialized need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Results 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"/>
          <p:cNvSpPr/>
          <p:nvPr/>
        </p:nvSpPr>
        <p:spPr>
          <a:xfrm>
            <a:off x="380880" y="1143000"/>
            <a:ext cx="8610840" cy="380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The form-based data entry interface was found to be user-friendly and attractive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The macro directive data processing mechanism was found to be valuable in clinical practice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The CEN architecture was found suitable for modelling beta-Thalassaemia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Java was found to be powerful enough for the needs of Electronic Healthcare Record application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Conclusion 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"/>
          <p:cNvSpPr/>
          <p:nvPr/>
        </p:nvSpPr>
        <p:spPr>
          <a:xfrm>
            <a:off x="380880" y="1143000"/>
            <a:ext cx="8610840" cy="380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JAnaemia appears to be a useful tool, which can improve the quality of care offered to beta-Thalassaemic patients in Greece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/>
          </p:nvPr>
        </p:nvSpPr>
        <p:spPr>
          <a:xfrm>
            <a:off x="304560" y="1447560"/>
            <a:ext cx="8381880" cy="510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00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111173"/>
                </a:solidFill>
                <a:latin typeface="Times New Roman"/>
              </a:rPr>
              <a:t>Beta-thalassaemia is a hereditary haemoglobinopathy</a:t>
            </a: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700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800" spc="-1" strike="noStrike">
                <a:solidFill>
                  <a:srgbClr val="111173"/>
                </a:solidFill>
                <a:latin typeface="Times New Roman"/>
              </a:rPr>
              <a:t>Its prevalence is high in countries around the Mediterranean basin. In Greece, it constitutes an important public health problem</a:t>
            </a: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700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800" spc="-1" strike="noStrike">
                <a:solidFill>
                  <a:srgbClr val="111173"/>
                </a:solidFill>
                <a:latin typeface="Times New Roman"/>
              </a:rPr>
              <a:t>It necessitates continuous transfusion and chelation sessions, as well as periodic follow-up examinations of various types (Cardiology, Hepatology, Haematology, Endocrinology, etc.)</a:t>
            </a: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700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800" spc="-1" strike="noStrike">
                <a:solidFill>
                  <a:srgbClr val="111173"/>
                </a:solidFill>
                <a:latin typeface="Times New Roman"/>
              </a:rPr>
              <a:t>Different services are offered in different, often distant, healthcare units</a:t>
            </a: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0" y="30492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beta-Thalassaemia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/>
          </p:nvPr>
        </p:nvSpPr>
        <p:spPr>
          <a:xfrm>
            <a:off x="304560" y="1447560"/>
            <a:ext cx="8381880" cy="510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00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111173"/>
                </a:solidFill>
                <a:latin typeface="Times New Roman"/>
              </a:rPr>
              <a:t>Medical records of patients suffering from beta-Thalassaemia are large and complex</a:t>
            </a: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700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111173"/>
                </a:solidFill>
                <a:latin typeface="Times New Roman"/>
              </a:rPr>
              <a:t>They are paper-based in the majority of Greek healthcare units. This causes difficulties in their:</a:t>
            </a: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60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111173"/>
                </a:solidFill>
                <a:latin typeface="Times New Roman"/>
              </a:rPr>
              <a:t>management, thus obstructing every day practice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60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111173"/>
                </a:solidFill>
                <a:latin typeface="Times New Roman"/>
              </a:rPr>
              <a:t>processing, thus hindering medical research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60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111173"/>
                </a:solidFill>
                <a:latin typeface="Times New Roman"/>
              </a:rPr>
              <a:t>communication, thus obstructing cooperation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700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800" spc="-1" strike="noStrike">
                <a:solidFill>
                  <a:srgbClr val="111173"/>
                </a:solidFill>
                <a:latin typeface="Times New Roman"/>
              </a:rPr>
              <a:t>Information is usually communicated between physicians via patients themselves. This causes:</a:t>
            </a: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60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400" spc="-1" strike="noStrike">
                <a:solidFill>
                  <a:srgbClr val="111173"/>
                </a:solidFill>
                <a:latin typeface="Times New Roman"/>
              </a:rPr>
              <a:t>loss of data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60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400" spc="-1" strike="noStrike">
                <a:solidFill>
                  <a:srgbClr val="111173"/>
                </a:solidFill>
                <a:latin typeface="Times New Roman"/>
              </a:rPr>
              <a:t>communication of inaccurate information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0" y="30492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Current Status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/>
          </p:nvPr>
        </p:nvSpPr>
        <p:spPr>
          <a:xfrm>
            <a:off x="304560" y="1447560"/>
            <a:ext cx="8381880" cy="510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00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800" spc="-1" strike="noStrike">
                <a:solidFill>
                  <a:srgbClr val="111173"/>
                </a:solidFill>
                <a:latin typeface="Times New Roman"/>
              </a:rPr>
              <a:t>It is a General Purpose Electronic Healthcare Record (EHCR) software</a:t>
            </a: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700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800" spc="-1" strike="noStrike">
                <a:solidFill>
                  <a:srgbClr val="111173"/>
                </a:solidFill>
                <a:latin typeface="Times New Roman"/>
              </a:rPr>
              <a:t>It has been customised for beta-Thalassaemia</a:t>
            </a: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700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800" spc="-1" strike="noStrike">
                <a:solidFill>
                  <a:srgbClr val="111173"/>
                </a:solidFill>
                <a:latin typeface="Times New Roman"/>
              </a:rPr>
              <a:t>It supports the systematic collection of all information related to beta-thalassaemic patients</a:t>
            </a: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700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800" spc="-1" strike="noStrike">
                <a:solidFill>
                  <a:srgbClr val="111173"/>
                </a:solidFill>
                <a:latin typeface="Times New Roman"/>
              </a:rPr>
              <a:t>It allows the communication of patient records between healthcare practitioners</a:t>
            </a: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700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800" spc="-1" strike="noStrike">
                <a:solidFill>
                  <a:srgbClr val="111173"/>
                </a:solidFill>
                <a:latin typeface="Times New Roman"/>
              </a:rPr>
              <a:t>It offers advanced processing functionality:</a:t>
            </a: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60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400" spc="-1" strike="noStrike">
                <a:solidFill>
                  <a:srgbClr val="111173"/>
                </a:solidFill>
                <a:latin typeface="Times New Roman"/>
              </a:rPr>
              <a:t>to support physicians in their every day tasks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60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400" spc="-1" strike="noStrike">
                <a:solidFill>
                  <a:srgbClr val="111173"/>
                </a:solidFill>
                <a:latin typeface="Times New Roman"/>
              </a:rPr>
              <a:t>to facilitate medical research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0" y="30492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JAnaemia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/>
          </p:nvPr>
        </p:nvSpPr>
        <p:spPr>
          <a:xfrm>
            <a:off x="304560" y="1447560"/>
            <a:ext cx="8381880" cy="510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00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800" spc="-1" strike="noStrike">
                <a:solidFill>
                  <a:srgbClr val="111173"/>
                </a:solidFill>
                <a:latin typeface="Times New Roman"/>
              </a:rPr>
              <a:t>Allows management and processing of </a:t>
            </a:r>
            <a:r>
              <a:rPr b="1" lang="en-AU" sz="2800" spc="-1" strike="noStrike">
                <a:solidFill>
                  <a:srgbClr val="111173"/>
                </a:solidFill>
                <a:latin typeface="Times New Roman"/>
              </a:rPr>
              <a:t>diverse</a:t>
            </a:r>
            <a:r>
              <a:rPr b="0" lang="en-AU" sz="2800" spc="-1" strike="noStrike">
                <a:solidFill>
                  <a:srgbClr val="111173"/>
                </a:solidFill>
                <a:latin typeface="Times New Roman"/>
              </a:rPr>
              <a:t> patient record contents</a:t>
            </a: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700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800" spc="-1" strike="noStrike">
                <a:solidFill>
                  <a:srgbClr val="111173"/>
                </a:solidFill>
                <a:latin typeface="Times New Roman"/>
              </a:rPr>
              <a:t>Is customizable to individual user needs</a:t>
            </a: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700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800" spc="-1" strike="noStrike">
                <a:solidFill>
                  <a:srgbClr val="111173"/>
                </a:solidFill>
                <a:latin typeface="Times New Roman"/>
              </a:rPr>
              <a:t>Provides a user-friendly, form-based interface</a:t>
            </a: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0" y="30492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Other JAnaemia features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"/>
          <p:cNvSpPr/>
          <p:nvPr/>
        </p:nvSpPr>
        <p:spPr>
          <a:xfrm>
            <a:off x="0" y="30492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JAnaemia is based...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304920" y="1447920"/>
            <a:ext cx="8534160" cy="434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00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111173"/>
                </a:solidFill>
                <a:latin typeface="Times New Roman"/>
              </a:rPr>
              <a:t>On the EHCR architecture proposed by CEN</a:t>
            </a:r>
            <a:r>
              <a:rPr b="0" lang="en-US" sz="2800" spc="-1" strike="noStrike" baseline="30000">
                <a:solidFill>
                  <a:srgbClr val="111173"/>
                </a:solidFill>
                <a:latin typeface="Times New Roman"/>
              </a:rPr>
              <a:t>1</a:t>
            </a: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700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800" spc="-1" strike="noStrike">
                <a:solidFill>
                  <a:srgbClr val="111173"/>
                </a:solidFill>
                <a:latin typeface="Times New Roman"/>
              </a:rPr>
              <a:t>The CEN architecture copes with issues of:</a:t>
            </a: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60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400" spc="-1" strike="noStrike">
                <a:solidFill>
                  <a:srgbClr val="111173"/>
                </a:solidFill>
                <a:latin typeface="Times New Roman"/>
              </a:rPr>
              <a:t>patient record diversity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60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400" spc="-1" strike="noStrike">
                <a:solidFill>
                  <a:srgbClr val="111173"/>
                </a:solidFill>
                <a:latin typeface="Times New Roman"/>
              </a:rPr>
              <a:t>clinical comprehensiveness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60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400" spc="-1" strike="noStrike">
                <a:solidFill>
                  <a:srgbClr val="111173"/>
                </a:solidFill>
                <a:latin typeface="Times New Roman"/>
              </a:rPr>
              <a:t>clinical analysis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60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400" spc="-1" strike="noStrike">
                <a:solidFill>
                  <a:srgbClr val="111173"/>
                </a:solidFill>
                <a:latin typeface="Times New Roman"/>
              </a:rPr>
              <a:t>record sharing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60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400" spc="-1" strike="noStrike">
                <a:solidFill>
                  <a:srgbClr val="111173"/>
                </a:solidFill>
                <a:latin typeface="Times New Roman"/>
              </a:rPr>
              <a:t>computational issues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60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400" spc="-1" strike="noStrike">
                <a:solidFill>
                  <a:srgbClr val="111173"/>
                </a:solidFill>
                <a:latin typeface="Times New Roman"/>
              </a:rPr>
              <a:t>educational issues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60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400" spc="-1" strike="noStrike">
                <a:solidFill>
                  <a:srgbClr val="111173"/>
                </a:solidFill>
                <a:latin typeface="Times New Roman"/>
              </a:rPr>
              <a:t>medico-legal issues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601"/>
              </a:spcBef>
              <a:buClr>
                <a:srgbClr val="111173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601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457200" y="6095880"/>
            <a:ext cx="838188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 baseline="30000">
                <a:solidFill>
                  <a:srgbClr val="111173"/>
                </a:solidFill>
                <a:latin typeface="Times New Roman"/>
              </a:rPr>
              <a:t>1</a:t>
            </a:r>
            <a:r>
              <a:rPr b="0" lang="en-US" sz="1800" spc="-1" strike="noStrike">
                <a:solidFill>
                  <a:srgbClr val="111173"/>
                </a:solidFill>
                <a:latin typeface="Times New Roman"/>
              </a:rPr>
              <a:t>Comite Europeen de Normalization, ENV 13606:1999 standard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"/>
          <p:cNvSpPr/>
          <p:nvPr/>
        </p:nvSpPr>
        <p:spPr>
          <a:xfrm>
            <a:off x="0" y="30492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EHCRs consist of compositions...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304920" y="4191120"/>
            <a:ext cx="8534160" cy="2514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Each composition contains all data recorded at one place and time of care delivery, in a single session with a particular healthcare professional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The figure shows the list of compositions comprising a patient record, ordered by date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58" name=""/>
          <p:cNvGrpSpPr/>
          <p:nvPr/>
        </p:nvGrpSpPr>
        <p:grpSpPr>
          <a:xfrm>
            <a:off x="533520" y="1447920"/>
            <a:ext cx="7716600" cy="2791080"/>
            <a:chOff x="533520" y="1447920"/>
            <a:chExt cx="7716600" cy="2791080"/>
          </a:xfrm>
        </p:grpSpPr>
        <p:pic>
          <p:nvPicPr>
            <p:cNvPr id="59" name="Figure1" descr=""/>
            <p:cNvPicPr/>
            <p:nvPr/>
          </p:nvPicPr>
          <p:blipFill>
            <a:blip r:embed="rId1"/>
            <a:stretch/>
          </p:blipFill>
          <p:spPr>
            <a:xfrm>
              <a:off x="533520" y="1447920"/>
              <a:ext cx="7716600" cy="2485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0" name=""/>
            <p:cNvSpPr/>
            <p:nvPr/>
          </p:nvSpPr>
          <p:spPr>
            <a:xfrm>
              <a:off x="609480" y="2590920"/>
              <a:ext cx="1295640" cy="22860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981080" y="2590920"/>
              <a:ext cx="1524240" cy="228600"/>
            </a:xfrm>
            <a:prstGeom prst="ellipse">
              <a:avLst/>
            </a:prstGeom>
            <a:noFill/>
            <a:ln w="936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429000" y="2590920"/>
              <a:ext cx="1295280" cy="228600"/>
            </a:xfrm>
            <a:prstGeom prst="ellipse">
              <a:avLst/>
            </a:prstGeom>
            <a:noFill/>
            <a:ln w="93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4648320" y="2590920"/>
              <a:ext cx="2743200" cy="228600"/>
            </a:xfrm>
            <a:prstGeom prst="ellipse">
              <a:avLst/>
            </a:prstGeom>
            <a:noFill/>
            <a:ln w="9360">
              <a:solidFill>
                <a:srgbClr val="0033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312920" y="3600360"/>
              <a:ext cx="1506600" cy="276480"/>
            </a:xfrm>
            <a:prstGeom prst="borderCallout1">
              <a:avLst>
                <a:gd name="adj1" fmla="val 18750"/>
                <a:gd name="adj2" fmla="val -8333"/>
                <a:gd name="adj3" fmla="val -271129"/>
                <a:gd name="adj4" fmla="val -17365"/>
              </a:avLst>
            </a:prstGeom>
            <a:solidFill>
              <a:srgbClr val="ffffff"/>
            </a:solidFill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Date of recording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124080" y="3657600"/>
              <a:ext cx="1506600" cy="276480"/>
            </a:xfrm>
            <a:prstGeom prst="borderCallout1">
              <a:avLst>
                <a:gd name="adj1" fmla="val 18750"/>
                <a:gd name="adj2" fmla="val -8333"/>
                <a:gd name="adj3" fmla="val -285824"/>
                <a:gd name="adj4" fmla="val -21592"/>
              </a:avLst>
            </a:prstGeom>
            <a:solidFill>
              <a:srgbClr val="ffffff"/>
            </a:solidFill>
            <a:ln w="936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Type of composition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4800600" y="3809880"/>
              <a:ext cx="1506600" cy="276480"/>
            </a:xfrm>
            <a:prstGeom prst="borderCallout1">
              <a:avLst>
                <a:gd name="adj1" fmla="val 18750"/>
                <a:gd name="adj2" fmla="val -8333"/>
                <a:gd name="adj3" fmla="val -371777"/>
                <a:gd name="adj4" fmla="val -14523"/>
              </a:avLst>
            </a:prstGeom>
            <a:solidFill>
              <a:srgbClr val="ffffff"/>
            </a:solidFill>
            <a:ln w="93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Responsible person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6705720" y="3962520"/>
              <a:ext cx="1506240" cy="276480"/>
            </a:xfrm>
            <a:prstGeom prst="borderCallout1">
              <a:avLst>
                <a:gd name="adj1" fmla="val 18750"/>
                <a:gd name="adj2" fmla="val -8333"/>
                <a:gd name="adj3" fmla="val -416120"/>
                <a:gd name="adj4" fmla="val -34763"/>
              </a:avLst>
            </a:prstGeom>
            <a:solidFill>
              <a:srgbClr val="ffffff"/>
            </a:solidFill>
            <a:ln w="9360">
              <a:solidFill>
                <a:srgbClr val="0033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Place of recording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e7eac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noFill/>
          <a:ln w="0">
            <a:noFill/>
          </a:ln>
          <a:effectLst>
            <a:outerShdw dist="40186" dir="4303641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540010"/>
                </a:solidFill>
                <a:latin typeface="Times New Roman"/>
              </a:rPr>
              <a:t>Compositions...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304920" y="1066680"/>
            <a:ext cx="853416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Comprise Data Items (DIs)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499"/>
              </a:spcBef>
              <a:buClr>
                <a:srgbClr val="111173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2000" spc="-1" strike="noStrike">
                <a:solidFill>
                  <a:srgbClr val="111173"/>
                </a:solidFill>
                <a:latin typeface="Times New Roman"/>
              </a:rPr>
              <a:t>DIs are the smallest structural units into which the content of EHCRs can be broken without losing its meaning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70" name=""/>
          <p:cNvGrpSpPr/>
          <p:nvPr/>
        </p:nvGrpSpPr>
        <p:grpSpPr>
          <a:xfrm>
            <a:off x="1219320" y="2286000"/>
            <a:ext cx="6421320" cy="4140360"/>
            <a:chOff x="1219320" y="2286000"/>
            <a:chExt cx="6421320" cy="4140360"/>
          </a:xfrm>
        </p:grpSpPr>
        <p:pic>
          <p:nvPicPr>
            <p:cNvPr id="71" name="Figure2" descr=""/>
            <p:cNvPicPr/>
            <p:nvPr/>
          </p:nvPicPr>
          <p:blipFill>
            <a:blip r:embed="rId1"/>
            <a:stretch/>
          </p:blipFill>
          <p:spPr>
            <a:xfrm>
              <a:off x="1219320" y="2286000"/>
              <a:ext cx="6421320" cy="3171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"/>
            <p:cNvSpPr/>
            <p:nvPr/>
          </p:nvSpPr>
          <p:spPr>
            <a:xfrm>
              <a:off x="1600200" y="3809880"/>
              <a:ext cx="1295280" cy="38124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581280" y="4724280"/>
              <a:ext cx="1905120" cy="38124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514600" y="4191120"/>
              <a:ext cx="838080" cy="152388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 flipH="1">
              <a:off x="3505320" y="5119560"/>
              <a:ext cx="799920" cy="59544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692440" y="5740560"/>
              <a:ext cx="1676520" cy="685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Examples of Data Items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0-10-04T12:51:42Z</dcterms:created>
  <dc:creator>Spyros Deftereos</dc:creator>
  <dc:description/>
  <dc:language>en-US</dc:language>
  <cp:lastModifiedBy>Eysenbach</cp:lastModifiedBy>
  <dcterms:modified xsi:type="dcterms:W3CDTF">2001-12-28T10:55:18Z</dcterms:modified>
  <cp:revision>44</cp:revision>
  <dc:subject/>
  <dc:title>A Java-based Electronic Healthcare Record software for beta-Thalassaemia</dc:title>
</cp:coreProperties>
</file>